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511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5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612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799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047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375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910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400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426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582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742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764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859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201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EC9DB96-3E71-1946-BE64-B42B9320E80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4247" r="4205" b="10545"/>
          <a:stretch/>
        </p:blipFill>
        <p:spPr>
          <a:xfrm>
            <a:off x="3931648" y="3776780"/>
            <a:ext cx="844061" cy="18989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456CB615-DC01-EC41-92FE-8E8954B43393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931648" y="3109861"/>
            <a:ext cx="844061" cy="63296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AE037C4D-51A3-B645-8BEE-694D3E04EDA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r="7734" b="-4630"/>
          <a:stretch/>
        </p:blipFill>
        <p:spPr>
          <a:xfrm>
            <a:off x="2048042" y="1984011"/>
            <a:ext cx="844061" cy="18989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3EA5E8B6-B1BF-B74F-9EE8-F48C0FFC9FB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3839"/>
          <a:stretch/>
        </p:blipFill>
        <p:spPr>
          <a:xfrm>
            <a:off x="2048042" y="1317092"/>
            <a:ext cx="844061" cy="63296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67B631B7-C71E-2E48-B024-D36545D4E28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l="5262" t="-2651" r="4601" b="2651"/>
          <a:stretch/>
        </p:blipFill>
        <p:spPr>
          <a:xfrm>
            <a:off x="3938579" y="1967240"/>
            <a:ext cx="844061" cy="18989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FBB88A54-A07F-C843-9679-155ED57BBCF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l="2733" t="-3" r="5997" b="5309"/>
          <a:stretch/>
        </p:blipFill>
        <p:spPr>
          <a:xfrm>
            <a:off x="3938579" y="1300321"/>
            <a:ext cx="844061" cy="63296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F56232D5-4253-6045-A427-21A904333AD0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036754" y="3776780"/>
            <a:ext cx="844061" cy="189891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xmlns="" id="{4562B409-4464-4A49-B13C-C9BF47C880D0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036754" y="3109861"/>
            <a:ext cx="844061" cy="632969"/>
          </a:xfrm>
          <a:prstGeom prst="rect">
            <a:avLst/>
          </a:prstGeom>
        </p:spPr>
      </p:pic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xmlns="" id="{C20ABDE3-D4C4-A44A-9E9E-07529F565EDF}"/>
              </a:ext>
            </a:extLst>
          </p:cNvPr>
          <p:cNvCxnSpPr>
            <a:cxnSpLocks/>
          </p:cNvCxnSpPr>
          <p:nvPr/>
        </p:nvCxnSpPr>
        <p:spPr>
          <a:xfrm>
            <a:off x="2886514" y="1539333"/>
            <a:ext cx="69191" cy="92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4" name="Group 43">
            <a:extLst>
              <a:ext uri="{FF2B5EF4-FFF2-40B4-BE49-F238E27FC236}">
                <a16:creationId xmlns:a16="http://schemas.microsoft.com/office/drawing/2014/main" xmlns="" id="{5A4B00F0-ED2B-8F4E-A3E0-170B9615EFCF}"/>
              </a:ext>
            </a:extLst>
          </p:cNvPr>
          <p:cNvGrpSpPr/>
          <p:nvPr/>
        </p:nvGrpSpPr>
        <p:grpSpPr>
          <a:xfrm>
            <a:off x="2072979" y="798475"/>
            <a:ext cx="882725" cy="575500"/>
            <a:chOff x="1363077" y="865014"/>
            <a:chExt cx="956285" cy="623458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3F27ED14-4CE3-F144-9791-CFC58E2F176E}"/>
                </a:ext>
              </a:extLst>
            </p:cNvPr>
            <p:cNvSpPr txBox="1"/>
            <p:nvPr/>
          </p:nvSpPr>
          <p:spPr>
            <a:xfrm rot="18900000">
              <a:off x="1363077" y="1133426"/>
              <a:ext cx="432757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Mock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66463D2C-7C2D-D146-B0D9-4FC64F2E7E3D}"/>
                </a:ext>
              </a:extLst>
            </p:cNvPr>
            <p:cNvSpPr txBox="1"/>
            <p:nvPr/>
          </p:nvSpPr>
          <p:spPr>
            <a:xfrm rot="18900000">
              <a:off x="1610418" y="1112519"/>
              <a:ext cx="512639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Control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2F025251-305B-F046-AD60-DB9B324B1F89}"/>
                </a:ext>
              </a:extLst>
            </p:cNvPr>
            <p:cNvSpPr txBox="1"/>
            <p:nvPr/>
          </p:nvSpPr>
          <p:spPr>
            <a:xfrm rot="18900000">
              <a:off x="1910361" y="1135183"/>
              <a:ext cx="403236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RIG-I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xmlns="" id="{AE1D6134-1FB9-D94E-9807-A6F5FBE091B8}"/>
                </a:ext>
              </a:extLst>
            </p:cNvPr>
            <p:cNvCxnSpPr/>
            <p:nvPr/>
          </p:nvCxnSpPr>
          <p:spPr>
            <a:xfrm>
              <a:off x="1790390" y="1062868"/>
              <a:ext cx="426876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FC69EC5C-4527-364A-BBB5-811419831FAB}"/>
                </a:ext>
              </a:extLst>
            </p:cNvPr>
            <p:cNvSpPr txBox="1"/>
            <p:nvPr/>
          </p:nvSpPr>
          <p:spPr>
            <a:xfrm>
              <a:off x="1795599" y="865014"/>
              <a:ext cx="444914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39" dirty="0"/>
                <a:t>siRNA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xmlns="" id="{F0737438-7A55-7E45-A433-8362C591F6EF}"/>
                </a:ext>
              </a:extLst>
            </p:cNvPr>
            <p:cNvCxnSpPr>
              <a:cxnSpLocks/>
            </p:cNvCxnSpPr>
            <p:nvPr/>
          </p:nvCxnSpPr>
          <p:spPr>
            <a:xfrm>
              <a:off x="2244406" y="1488372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xmlns="" id="{5B366C30-9CA5-2946-9224-2677AD50108F}"/>
              </a:ext>
            </a:extLst>
          </p:cNvPr>
          <p:cNvCxnSpPr>
            <a:cxnSpLocks/>
          </p:cNvCxnSpPr>
          <p:nvPr/>
        </p:nvCxnSpPr>
        <p:spPr>
          <a:xfrm>
            <a:off x="2886514" y="1628001"/>
            <a:ext cx="69191" cy="92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3" name="Group 72">
            <a:extLst>
              <a:ext uri="{FF2B5EF4-FFF2-40B4-BE49-F238E27FC236}">
                <a16:creationId xmlns:a16="http://schemas.microsoft.com/office/drawing/2014/main" xmlns="" id="{3ECFBD23-C3AA-324A-8228-597A78E8C78E}"/>
              </a:ext>
            </a:extLst>
          </p:cNvPr>
          <p:cNvGrpSpPr/>
          <p:nvPr/>
        </p:nvGrpSpPr>
        <p:grpSpPr>
          <a:xfrm>
            <a:off x="1630666" y="1434308"/>
            <a:ext cx="452367" cy="739218"/>
            <a:chOff x="883904" y="1553832"/>
            <a:chExt cx="490063" cy="800820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49B6F247-C0AD-2A43-B0C4-4CC7FC1DF87E}"/>
                </a:ext>
              </a:extLst>
            </p:cNvPr>
            <p:cNvSpPr txBox="1"/>
            <p:nvPr/>
          </p:nvSpPr>
          <p:spPr>
            <a:xfrm>
              <a:off x="970732" y="1553832"/>
              <a:ext cx="403235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39" dirty="0"/>
                <a:t>RIG-I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C87A6465-E0EF-E54C-ABA8-9977BC783EFF}"/>
                </a:ext>
              </a:extLst>
            </p:cNvPr>
            <p:cNvSpPr txBox="1"/>
            <p:nvPr/>
          </p:nvSpPr>
          <p:spPr>
            <a:xfrm>
              <a:off x="883904" y="2131396"/>
              <a:ext cx="490063" cy="223256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l-GR" sz="739" dirty="0"/>
                <a:t>β</a:t>
              </a:r>
              <a:r>
                <a:rPr lang="en-US" sz="739" dirty="0"/>
                <a:t>-actin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541135C8-8EEF-0A4D-8C0A-3CEDF693F7CA}"/>
              </a:ext>
            </a:extLst>
          </p:cNvPr>
          <p:cNvSpPr txBox="1"/>
          <p:nvPr/>
        </p:nvSpPr>
        <p:spPr>
          <a:xfrm>
            <a:off x="2902635" y="1271256"/>
            <a:ext cx="328936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739" dirty="0"/>
              <a:t>150</a:t>
            </a:r>
            <a:endParaRPr lang="en-US" sz="739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EF8B3646-884F-EE41-B30B-84D458A95911}"/>
              </a:ext>
            </a:extLst>
          </p:cNvPr>
          <p:cNvSpPr txBox="1"/>
          <p:nvPr/>
        </p:nvSpPr>
        <p:spPr>
          <a:xfrm>
            <a:off x="2902635" y="1417231"/>
            <a:ext cx="328936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739" dirty="0"/>
              <a:t>100</a:t>
            </a:r>
            <a:endParaRPr lang="en-US" sz="739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A223724-C179-954C-8653-57ACD44D68AB}"/>
              </a:ext>
            </a:extLst>
          </p:cNvPr>
          <p:cNvSpPr txBox="1"/>
          <p:nvPr/>
        </p:nvSpPr>
        <p:spPr>
          <a:xfrm>
            <a:off x="2902634" y="1539333"/>
            <a:ext cx="280846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739" dirty="0"/>
              <a:t>75</a:t>
            </a:r>
            <a:endParaRPr lang="en-US" sz="739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6F6823C0-984D-0945-9A04-ADCBEAC4DDA3}"/>
              </a:ext>
            </a:extLst>
          </p:cNvPr>
          <p:cNvSpPr txBox="1"/>
          <p:nvPr/>
        </p:nvSpPr>
        <p:spPr>
          <a:xfrm>
            <a:off x="2902633" y="1101489"/>
            <a:ext cx="330540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39" dirty="0" err="1"/>
              <a:t>kDa</a:t>
            </a:r>
            <a:endParaRPr lang="en-US" sz="739" dirty="0"/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xmlns="" id="{810B11CA-3C1E-1144-818D-C0EEAFDD1C83}"/>
              </a:ext>
            </a:extLst>
          </p:cNvPr>
          <p:cNvGrpSpPr/>
          <p:nvPr/>
        </p:nvGrpSpPr>
        <p:grpSpPr>
          <a:xfrm>
            <a:off x="3959302" y="802561"/>
            <a:ext cx="881411" cy="455468"/>
            <a:chOff x="1363077" y="865014"/>
            <a:chExt cx="954864" cy="493424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6ACFD17A-C294-534F-AB2D-96F98CBF5B0B}"/>
                </a:ext>
              </a:extLst>
            </p:cNvPr>
            <p:cNvSpPr txBox="1"/>
            <p:nvPr/>
          </p:nvSpPr>
          <p:spPr>
            <a:xfrm rot="18900000">
              <a:off x="1363077" y="1133427"/>
              <a:ext cx="432758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Mock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1AB04E03-CA91-7E48-BF33-4EC33D85D662}"/>
                </a:ext>
              </a:extLst>
            </p:cNvPr>
            <p:cNvSpPr txBox="1"/>
            <p:nvPr/>
          </p:nvSpPr>
          <p:spPr>
            <a:xfrm rot="18900000">
              <a:off x="1610419" y="1112518"/>
              <a:ext cx="512641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Control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6ECFEC9D-CAFC-614F-87F9-C12013C60666}"/>
                </a:ext>
              </a:extLst>
            </p:cNvPr>
            <p:cNvSpPr txBox="1"/>
            <p:nvPr/>
          </p:nvSpPr>
          <p:spPr>
            <a:xfrm rot="18900000">
              <a:off x="1906022" y="1135182"/>
              <a:ext cx="411919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TBK1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xmlns="" id="{992762DF-C977-374A-81D2-B16CF89CFB58}"/>
                </a:ext>
              </a:extLst>
            </p:cNvPr>
            <p:cNvCxnSpPr/>
            <p:nvPr/>
          </p:nvCxnSpPr>
          <p:spPr>
            <a:xfrm>
              <a:off x="1790390" y="1062868"/>
              <a:ext cx="426876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D4EC2118-61DA-F145-B35B-DAAE7475205C}"/>
                </a:ext>
              </a:extLst>
            </p:cNvPr>
            <p:cNvSpPr txBox="1"/>
            <p:nvPr/>
          </p:nvSpPr>
          <p:spPr>
            <a:xfrm>
              <a:off x="1795600" y="865014"/>
              <a:ext cx="444915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39" dirty="0"/>
                <a:t>siRNA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xmlns="" id="{B80B90FE-2E5A-7D47-8769-C75ACE305EAE}"/>
              </a:ext>
            </a:extLst>
          </p:cNvPr>
          <p:cNvGrpSpPr/>
          <p:nvPr/>
        </p:nvGrpSpPr>
        <p:grpSpPr>
          <a:xfrm>
            <a:off x="2065917" y="2609450"/>
            <a:ext cx="866985" cy="466649"/>
            <a:chOff x="1363077" y="865014"/>
            <a:chExt cx="939233" cy="505535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xmlns="" id="{8E5308D3-EBAC-8B43-BC93-B3859526FF8E}"/>
                </a:ext>
              </a:extLst>
            </p:cNvPr>
            <p:cNvSpPr txBox="1"/>
            <p:nvPr/>
          </p:nvSpPr>
          <p:spPr>
            <a:xfrm rot="18900000">
              <a:off x="1363077" y="1133426"/>
              <a:ext cx="432757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Mock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FC136B35-5A2D-BA4E-B732-5992595F2D6D}"/>
                </a:ext>
              </a:extLst>
            </p:cNvPr>
            <p:cNvSpPr txBox="1"/>
            <p:nvPr/>
          </p:nvSpPr>
          <p:spPr>
            <a:xfrm rot="18900000">
              <a:off x="1610417" y="1112518"/>
              <a:ext cx="512640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Control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xmlns="" id="{C7D82689-8F91-274D-B381-342F483B9DE7}"/>
                </a:ext>
              </a:extLst>
            </p:cNvPr>
            <p:cNvSpPr txBox="1"/>
            <p:nvPr/>
          </p:nvSpPr>
          <p:spPr>
            <a:xfrm rot="18900000">
              <a:off x="1921650" y="1147294"/>
              <a:ext cx="380660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IRF3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xmlns="" id="{B6A1D102-F475-804D-B0B4-B26D789E48A2}"/>
                </a:ext>
              </a:extLst>
            </p:cNvPr>
            <p:cNvCxnSpPr/>
            <p:nvPr/>
          </p:nvCxnSpPr>
          <p:spPr>
            <a:xfrm>
              <a:off x="1790390" y="1062868"/>
              <a:ext cx="426876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xmlns="" id="{EA4DB864-9A9C-5144-92F2-33164B1018DF}"/>
                </a:ext>
              </a:extLst>
            </p:cNvPr>
            <p:cNvSpPr txBox="1"/>
            <p:nvPr/>
          </p:nvSpPr>
          <p:spPr>
            <a:xfrm>
              <a:off x="1795602" y="865014"/>
              <a:ext cx="444914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39" dirty="0"/>
                <a:t>siRNA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xmlns="" id="{6595FAA9-1E42-0041-AF23-4D363BD14B6E}"/>
              </a:ext>
            </a:extLst>
          </p:cNvPr>
          <p:cNvGrpSpPr/>
          <p:nvPr/>
        </p:nvGrpSpPr>
        <p:grpSpPr>
          <a:xfrm>
            <a:off x="3944055" y="2607633"/>
            <a:ext cx="866985" cy="466649"/>
            <a:chOff x="1363077" y="865014"/>
            <a:chExt cx="939233" cy="505535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09B9EB24-EDFA-B249-B9CF-3A3591A2407B}"/>
                </a:ext>
              </a:extLst>
            </p:cNvPr>
            <p:cNvSpPr txBox="1"/>
            <p:nvPr/>
          </p:nvSpPr>
          <p:spPr>
            <a:xfrm rot="18900000">
              <a:off x="1363077" y="1133426"/>
              <a:ext cx="432757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Mock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D52A66E6-915C-7645-A3C6-082C1B578D5A}"/>
                </a:ext>
              </a:extLst>
            </p:cNvPr>
            <p:cNvSpPr txBox="1"/>
            <p:nvPr/>
          </p:nvSpPr>
          <p:spPr>
            <a:xfrm rot="18900000">
              <a:off x="1610417" y="1112518"/>
              <a:ext cx="512640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Control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6E0B6AD2-A1E7-E849-B04E-4F828EA65173}"/>
                </a:ext>
              </a:extLst>
            </p:cNvPr>
            <p:cNvSpPr txBox="1"/>
            <p:nvPr/>
          </p:nvSpPr>
          <p:spPr>
            <a:xfrm rot="18900000">
              <a:off x="1921650" y="1147294"/>
              <a:ext cx="380660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IRF7</a:t>
              </a:r>
            </a:p>
          </p:txBody>
        </p: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xmlns="" id="{0F663D9D-6681-C54A-B0E1-F2901D4389DD}"/>
                </a:ext>
              </a:extLst>
            </p:cNvPr>
            <p:cNvCxnSpPr/>
            <p:nvPr/>
          </p:nvCxnSpPr>
          <p:spPr>
            <a:xfrm>
              <a:off x="1790390" y="1062868"/>
              <a:ext cx="426876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83EA330F-3156-9A4D-8388-42919EE7A288}"/>
                </a:ext>
              </a:extLst>
            </p:cNvPr>
            <p:cNvSpPr txBox="1"/>
            <p:nvPr/>
          </p:nvSpPr>
          <p:spPr>
            <a:xfrm>
              <a:off x="1795602" y="865014"/>
              <a:ext cx="444914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39" dirty="0"/>
                <a:t>siRNA</a:t>
              </a: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xmlns="" id="{C1AF04D0-AAF2-9B49-B10C-FFFAE1B02E04}"/>
              </a:ext>
            </a:extLst>
          </p:cNvPr>
          <p:cNvGrpSpPr/>
          <p:nvPr/>
        </p:nvGrpSpPr>
        <p:grpSpPr>
          <a:xfrm>
            <a:off x="3532069" y="1358622"/>
            <a:ext cx="452367" cy="811890"/>
            <a:chOff x="883904" y="1475104"/>
            <a:chExt cx="490063" cy="879548"/>
          </a:xfrm>
        </p:grpSpPr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xmlns="" id="{7F06D778-ABC4-D244-8015-9A8B3B80936D}"/>
                </a:ext>
              </a:extLst>
            </p:cNvPr>
            <p:cNvSpPr txBox="1"/>
            <p:nvPr/>
          </p:nvSpPr>
          <p:spPr>
            <a:xfrm>
              <a:off x="962050" y="1475104"/>
              <a:ext cx="411917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39" dirty="0"/>
                <a:t>TBK1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xmlns="" id="{5F2E10BC-D2B0-BD44-B80C-7FB946089F02}"/>
                </a:ext>
              </a:extLst>
            </p:cNvPr>
            <p:cNvSpPr txBox="1"/>
            <p:nvPr/>
          </p:nvSpPr>
          <p:spPr>
            <a:xfrm>
              <a:off x="883904" y="2131396"/>
              <a:ext cx="490063" cy="223256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l-GR" sz="739" dirty="0"/>
                <a:t>β</a:t>
              </a:r>
              <a:r>
                <a:rPr lang="en-US" sz="739" dirty="0"/>
                <a:t>-actin</a:t>
              </a: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xmlns="" id="{0E3A3C19-298B-F543-9E64-80AF974C47E9}"/>
              </a:ext>
            </a:extLst>
          </p:cNvPr>
          <p:cNvGrpSpPr/>
          <p:nvPr/>
        </p:nvGrpSpPr>
        <p:grpSpPr>
          <a:xfrm>
            <a:off x="1624001" y="3342864"/>
            <a:ext cx="452367" cy="627419"/>
            <a:chOff x="883903" y="1674947"/>
            <a:chExt cx="490064" cy="679704"/>
          </a:xfrm>
        </p:grpSpPr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2857D1C4-3058-2147-B551-45CBACE5FE0A}"/>
                </a:ext>
              </a:extLst>
            </p:cNvPr>
            <p:cNvSpPr txBox="1"/>
            <p:nvPr/>
          </p:nvSpPr>
          <p:spPr>
            <a:xfrm>
              <a:off x="993308" y="1674947"/>
              <a:ext cx="380659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39" dirty="0"/>
                <a:t>IRF3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7D404B2E-4419-9647-AAD1-54F9C04F410A}"/>
                </a:ext>
              </a:extLst>
            </p:cNvPr>
            <p:cNvSpPr txBox="1"/>
            <p:nvPr/>
          </p:nvSpPr>
          <p:spPr>
            <a:xfrm>
              <a:off x="883903" y="2131396"/>
              <a:ext cx="490064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l-GR" sz="739" dirty="0"/>
                <a:t>β</a:t>
              </a:r>
              <a:r>
                <a:rPr lang="en-US" sz="739" dirty="0"/>
                <a:t>-actin</a:t>
              </a:r>
            </a:p>
          </p:txBody>
        </p: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xmlns="" id="{863081EA-A310-104B-988C-251606881CF3}"/>
              </a:ext>
            </a:extLst>
          </p:cNvPr>
          <p:cNvGrpSpPr/>
          <p:nvPr/>
        </p:nvGrpSpPr>
        <p:grpSpPr>
          <a:xfrm>
            <a:off x="3517449" y="3208706"/>
            <a:ext cx="452367" cy="761578"/>
            <a:chOff x="883903" y="1529608"/>
            <a:chExt cx="490064" cy="825044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CF344768-17B7-C846-9FE7-213F4E3C0DEF}"/>
                </a:ext>
              </a:extLst>
            </p:cNvPr>
            <p:cNvSpPr txBox="1"/>
            <p:nvPr/>
          </p:nvSpPr>
          <p:spPr>
            <a:xfrm>
              <a:off x="993308" y="1529608"/>
              <a:ext cx="380659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39" dirty="0"/>
                <a:t>IRF7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2862C0F7-5164-9741-9D3C-151550E5E4DB}"/>
                </a:ext>
              </a:extLst>
            </p:cNvPr>
            <p:cNvSpPr txBox="1"/>
            <p:nvPr/>
          </p:nvSpPr>
          <p:spPr>
            <a:xfrm>
              <a:off x="883903" y="2131396"/>
              <a:ext cx="490064" cy="223256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l-GR" sz="739" dirty="0"/>
                <a:t>β</a:t>
              </a:r>
              <a:r>
                <a:rPr lang="en-US" sz="739" dirty="0"/>
                <a:t>-actin</a:t>
              </a:r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xmlns="" id="{DE81F075-F06D-E74E-9D05-7A2B33680D1D}"/>
              </a:ext>
            </a:extLst>
          </p:cNvPr>
          <p:cNvGrpSpPr/>
          <p:nvPr/>
        </p:nvGrpSpPr>
        <p:grpSpPr>
          <a:xfrm>
            <a:off x="4770116" y="2828860"/>
            <a:ext cx="346660" cy="766905"/>
            <a:chOff x="4944227" y="3424991"/>
            <a:chExt cx="375549" cy="830813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xmlns="" id="{E63E1C33-4104-5C46-803C-6F3A5F691926}"/>
                </a:ext>
              </a:extLst>
            </p:cNvPr>
            <p:cNvSpPr txBox="1"/>
            <p:nvPr/>
          </p:nvSpPr>
          <p:spPr>
            <a:xfrm>
              <a:off x="4961690" y="3767046"/>
              <a:ext cx="304250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75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xmlns="" id="{DF50481F-9C3B-DF4A-AB78-98D177730222}"/>
                </a:ext>
              </a:extLst>
            </p:cNvPr>
            <p:cNvSpPr txBox="1"/>
            <p:nvPr/>
          </p:nvSpPr>
          <p:spPr>
            <a:xfrm>
              <a:off x="4961690" y="3645241"/>
              <a:ext cx="356348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739" dirty="0"/>
                <a:t>1</a:t>
              </a:r>
              <a:r>
                <a:rPr lang="en-US" sz="739" dirty="0"/>
                <a:t>0</a:t>
              </a:r>
              <a:r>
                <a:rPr lang="el-GR" sz="739" dirty="0"/>
                <a:t>0</a:t>
              </a:r>
              <a:endParaRPr lang="en-US" sz="739" dirty="0"/>
            </a:p>
          </p:txBody>
        </p: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xmlns="" id="{64C030B1-E366-F24B-8F47-E4BB092F61B5}"/>
                </a:ext>
              </a:extLst>
            </p:cNvPr>
            <p:cNvCxnSpPr>
              <a:cxnSpLocks/>
            </p:cNvCxnSpPr>
            <p:nvPr/>
          </p:nvCxnSpPr>
          <p:spPr>
            <a:xfrm>
              <a:off x="4946416" y="3756597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xmlns="" id="{82016361-A997-BA4E-93D5-212BF8CA3C09}"/>
                </a:ext>
              </a:extLst>
            </p:cNvPr>
            <p:cNvCxnSpPr>
              <a:cxnSpLocks/>
            </p:cNvCxnSpPr>
            <p:nvPr/>
          </p:nvCxnSpPr>
          <p:spPr>
            <a:xfrm>
              <a:off x="4944227" y="3850874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xmlns="" id="{E9E9C0B4-6839-A648-B00F-2EA0AFC93183}"/>
                </a:ext>
              </a:extLst>
            </p:cNvPr>
            <p:cNvCxnSpPr>
              <a:cxnSpLocks/>
            </p:cNvCxnSpPr>
            <p:nvPr/>
          </p:nvCxnSpPr>
          <p:spPr>
            <a:xfrm>
              <a:off x="4944227" y="4128605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xmlns="" id="{7DEA3E02-1B01-814C-851E-B887588E3A8E}"/>
                </a:ext>
              </a:extLst>
            </p:cNvPr>
            <p:cNvSpPr txBox="1"/>
            <p:nvPr/>
          </p:nvSpPr>
          <p:spPr>
            <a:xfrm>
              <a:off x="4961690" y="4032549"/>
              <a:ext cx="304250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50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xmlns="" id="{DB64284E-1EF7-DB45-B8C0-BA483E9554B4}"/>
                </a:ext>
              </a:extLst>
            </p:cNvPr>
            <p:cNvSpPr txBox="1"/>
            <p:nvPr/>
          </p:nvSpPr>
          <p:spPr>
            <a:xfrm>
              <a:off x="4961690" y="3424991"/>
              <a:ext cx="358086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 err="1"/>
                <a:t>kDa</a:t>
              </a:r>
              <a:endParaRPr lang="en-US" sz="739" dirty="0"/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xmlns="" id="{7B0F9CF9-2C13-144B-A44B-AD2F377A870A}"/>
              </a:ext>
            </a:extLst>
          </p:cNvPr>
          <p:cNvGrpSpPr/>
          <p:nvPr/>
        </p:nvGrpSpPr>
        <p:grpSpPr>
          <a:xfrm>
            <a:off x="2872381" y="2853355"/>
            <a:ext cx="346660" cy="772492"/>
            <a:chOff x="4944227" y="3424991"/>
            <a:chExt cx="375549" cy="836867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xmlns="" id="{5A751452-BFDE-2B4E-B2B6-9A812643E8FF}"/>
                </a:ext>
              </a:extLst>
            </p:cNvPr>
            <p:cNvSpPr txBox="1"/>
            <p:nvPr/>
          </p:nvSpPr>
          <p:spPr>
            <a:xfrm>
              <a:off x="4961690" y="4038602"/>
              <a:ext cx="304250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5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xmlns="" id="{88A47541-63FB-914E-A40F-7B41274716BD}"/>
                </a:ext>
              </a:extLst>
            </p:cNvPr>
            <p:cNvSpPr txBox="1"/>
            <p:nvPr/>
          </p:nvSpPr>
          <p:spPr>
            <a:xfrm>
              <a:off x="4961690" y="3767044"/>
              <a:ext cx="304250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75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xmlns="" id="{3B3B2102-0FE6-FB4F-A846-014AEB5C482E}"/>
                </a:ext>
              </a:extLst>
            </p:cNvPr>
            <p:cNvSpPr txBox="1"/>
            <p:nvPr/>
          </p:nvSpPr>
          <p:spPr>
            <a:xfrm>
              <a:off x="4961690" y="3645242"/>
              <a:ext cx="356348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739" dirty="0"/>
                <a:t>1</a:t>
              </a:r>
              <a:r>
                <a:rPr lang="en-US" sz="739" dirty="0"/>
                <a:t>0</a:t>
              </a:r>
              <a:r>
                <a:rPr lang="el-GR" sz="739" dirty="0"/>
                <a:t>0</a:t>
              </a:r>
              <a:endParaRPr lang="en-US" sz="739" dirty="0"/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xmlns="" id="{28C0ACC3-6D8E-1B4F-AB18-83B2E2D30457}"/>
                </a:ext>
              </a:extLst>
            </p:cNvPr>
            <p:cNvCxnSpPr>
              <a:cxnSpLocks/>
            </p:cNvCxnSpPr>
            <p:nvPr/>
          </p:nvCxnSpPr>
          <p:spPr>
            <a:xfrm>
              <a:off x="4946416" y="3756597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xmlns="" id="{0248638C-7D84-FB41-A7D7-4C6C53A78E71}"/>
                </a:ext>
              </a:extLst>
            </p:cNvPr>
            <p:cNvCxnSpPr>
              <a:cxnSpLocks/>
            </p:cNvCxnSpPr>
            <p:nvPr/>
          </p:nvCxnSpPr>
          <p:spPr>
            <a:xfrm>
              <a:off x="4944227" y="3850874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xmlns="" id="{164C180D-24B1-A448-B37E-9BF011C07DA1}"/>
                </a:ext>
              </a:extLst>
            </p:cNvPr>
            <p:cNvCxnSpPr>
              <a:cxnSpLocks/>
            </p:cNvCxnSpPr>
            <p:nvPr/>
          </p:nvCxnSpPr>
          <p:spPr>
            <a:xfrm>
              <a:off x="4944227" y="4134658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xmlns="" id="{D8736F75-E957-D44E-B196-64B69C74A029}"/>
                </a:ext>
              </a:extLst>
            </p:cNvPr>
            <p:cNvSpPr txBox="1"/>
            <p:nvPr/>
          </p:nvSpPr>
          <p:spPr>
            <a:xfrm>
              <a:off x="4961690" y="3424991"/>
              <a:ext cx="358086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 err="1"/>
                <a:t>kDa</a:t>
              </a:r>
              <a:endParaRPr lang="en-US" sz="739" dirty="0"/>
            </a:p>
          </p:txBody>
        </p: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xmlns="" id="{7B17EA3A-BB75-D544-A5CC-53EC72ADA13B}"/>
              </a:ext>
            </a:extLst>
          </p:cNvPr>
          <p:cNvGrpSpPr/>
          <p:nvPr/>
        </p:nvGrpSpPr>
        <p:grpSpPr>
          <a:xfrm>
            <a:off x="4775710" y="1053162"/>
            <a:ext cx="346660" cy="794856"/>
            <a:chOff x="4944227" y="3424991"/>
            <a:chExt cx="375549" cy="861094"/>
          </a:xfrm>
        </p:grpSpPr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xmlns="" id="{79813D73-025D-B049-A68D-2DB6083DFC7F}"/>
                </a:ext>
              </a:extLst>
            </p:cNvPr>
            <p:cNvSpPr txBox="1"/>
            <p:nvPr/>
          </p:nvSpPr>
          <p:spPr>
            <a:xfrm>
              <a:off x="4961690" y="4062829"/>
              <a:ext cx="304250" cy="223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50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xmlns="" id="{2EDE5379-8AE0-EF4F-B0D9-FAE3EEB4A7F5}"/>
                </a:ext>
              </a:extLst>
            </p:cNvPr>
            <p:cNvSpPr txBox="1"/>
            <p:nvPr/>
          </p:nvSpPr>
          <p:spPr>
            <a:xfrm>
              <a:off x="4961690" y="3791268"/>
              <a:ext cx="304250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/>
                <a:t>75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xmlns="" id="{5E2CE8DC-F8FF-3744-AB79-91935C591EDD}"/>
                </a:ext>
              </a:extLst>
            </p:cNvPr>
            <p:cNvSpPr txBox="1"/>
            <p:nvPr/>
          </p:nvSpPr>
          <p:spPr>
            <a:xfrm>
              <a:off x="4961690" y="3645241"/>
              <a:ext cx="356348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739" dirty="0"/>
                <a:t>1</a:t>
              </a:r>
              <a:r>
                <a:rPr lang="en-US" sz="739" dirty="0"/>
                <a:t>0</a:t>
              </a:r>
              <a:r>
                <a:rPr lang="el-GR" sz="739" dirty="0"/>
                <a:t>0</a:t>
              </a:r>
              <a:endParaRPr lang="en-US" sz="739" dirty="0"/>
            </a:p>
          </p:txBody>
        </p: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xmlns="" id="{24EA6E32-C618-9141-ADA9-815D8BFF8F83}"/>
                </a:ext>
              </a:extLst>
            </p:cNvPr>
            <p:cNvCxnSpPr>
              <a:cxnSpLocks/>
            </p:cNvCxnSpPr>
            <p:nvPr/>
          </p:nvCxnSpPr>
          <p:spPr>
            <a:xfrm>
              <a:off x="4946416" y="3756597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xmlns="" id="{E2C39A5F-7FB4-694C-8F79-7FB9AB0EEE84}"/>
                </a:ext>
              </a:extLst>
            </p:cNvPr>
            <p:cNvCxnSpPr>
              <a:cxnSpLocks/>
            </p:cNvCxnSpPr>
            <p:nvPr/>
          </p:nvCxnSpPr>
          <p:spPr>
            <a:xfrm>
              <a:off x="4944227" y="3893264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xmlns="" id="{B27C0D4C-4317-4642-BD3E-C3D919402179}"/>
                </a:ext>
              </a:extLst>
            </p:cNvPr>
            <p:cNvCxnSpPr>
              <a:cxnSpLocks/>
            </p:cNvCxnSpPr>
            <p:nvPr/>
          </p:nvCxnSpPr>
          <p:spPr>
            <a:xfrm>
              <a:off x="4944227" y="4170997"/>
              <a:ext cx="74956" cy="10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xmlns="" id="{5AB05265-4906-E740-B6AD-3D1EB7F3391A}"/>
                </a:ext>
              </a:extLst>
            </p:cNvPr>
            <p:cNvSpPr txBox="1"/>
            <p:nvPr/>
          </p:nvSpPr>
          <p:spPr>
            <a:xfrm>
              <a:off x="4961690" y="3424991"/>
              <a:ext cx="358086" cy="223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39" dirty="0" err="1"/>
                <a:t>kDa</a:t>
              </a:r>
              <a:endParaRPr lang="en-US" sz="739" dirty="0"/>
            </a:p>
          </p:txBody>
        </p:sp>
      </p:grp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B60D9258-36EA-944D-BCCE-A49012CCC7BD}"/>
              </a:ext>
            </a:extLst>
          </p:cNvPr>
          <p:cNvSpPr txBox="1"/>
          <p:nvPr/>
        </p:nvSpPr>
        <p:spPr>
          <a:xfrm>
            <a:off x="1520094" y="670435"/>
            <a:ext cx="280846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92" dirty="0"/>
              <a:t>A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A675FCD3-099E-5240-9E89-FE63AAC18DB8}"/>
              </a:ext>
            </a:extLst>
          </p:cNvPr>
          <p:cNvSpPr txBox="1"/>
          <p:nvPr/>
        </p:nvSpPr>
        <p:spPr>
          <a:xfrm>
            <a:off x="3418271" y="670435"/>
            <a:ext cx="274434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92" dirty="0"/>
              <a:t>B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19D77345-79DD-A740-B53B-A5FAD30C9C38}"/>
              </a:ext>
            </a:extLst>
          </p:cNvPr>
          <p:cNvSpPr txBox="1"/>
          <p:nvPr/>
        </p:nvSpPr>
        <p:spPr>
          <a:xfrm>
            <a:off x="3418271" y="2496599"/>
            <a:ext cx="287258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92" dirty="0"/>
              <a:t>D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7064594D-EE39-F240-92CD-FC764351F359}"/>
              </a:ext>
            </a:extLst>
          </p:cNvPr>
          <p:cNvSpPr txBox="1"/>
          <p:nvPr/>
        </p:nvSpPr>
        <p:spPr>
          <a:xfrm>
            <a:off x="1520093" y="2496599"/>
            <a:ext cx="272832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92" dirty="0"/>
              <a:t>C</a:t>
            </a: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xmlns="" id="{64FEA7F3-1DFD-2E4A-AF67-3A27AEA32183}"/>
              </a:ext>
            </a:extLst>
          </p:cNvPr>
          <p:cNvSpPr/>
          <p:nvPr/>
        </p:nvSpPr>
        <p:spPr>
          <a:xfrm>
            <a:off x="647875" y="4847175"/>
            <a:ext cx="5661445" cy="6038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8" b="1" dirty="0"/>
              <a:t>S1 Fig. Western blot analysis for siRNA efficiency in mouse BMMs. </a:t>
            </a:r>
            <a:r>
              <a:rPr lang="en-US" sz="1108" dirty="0"/>
              <a:t>A) RIG-I; B) TBK1; C) IRF3 and D) IRF7. </a:t>
            </a:r>
            <a:r>
              <a:rPr lang="el-GR" sz="1108" dirty="0"/>
              <a:t>β-</a:t>
            </a:r>
            <a:r>
              <a:rPr lang="en-US" sz="1108" dirty="0"/>
              <a:t>actin served as a load control. Mock, untreated; Control, negative control siRNA. Data shown are representative of three independent experiments.  </a:t>
            </a:r>
          </a:p>
        </p:txBody>
      </p:sp>
    </p:spTree>
    <p:extLst>
      <p:ext uri="{BB962C8B-B14F-4D97-AF65-F5344CB8AC3E}">
        <p14:creationId xmlns:p14="http://schemas.microsoft.com/office/powerpoint/2010/main" val="1515111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10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Notre Dam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Schorey</dc:creator>
  <cp:lastModifiedBy>Jeffrey Schorey</cp:lastModifiedBy>
  <cp:revision>2</cp:revision>
  <dcterms:created xsi:type="dcterms:W3CDTF">2020-04-29T17:59:52Z</dcterms:created>
  <dcterms:modified xsi:type="dcterms:W3CDTF">2020-04-29T18:07:41Z</dcterms:modified>
</cp:coreProperties>
</file>